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5143500" type="screen16x9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86A8C98-401F-A212-3E9B-6C9C81503DAF}" v="4" dt="2023-04-14T10:53:19.897"/>
    <p1510:client id="{1A66E31C-FF88-BB46-491D-3BD2A169B11B}" v="124" dt="2021-12-16T14:51:45.907"/>
    <p1510:client id="{1B620678-9DFA-DE2E-88E9-327F69CB34F7}" v="11" dt="2021-12-20T15:56:32.357"/>
    <p1510:client id="{256B00A2-FE5C-C71D-E383-09CCF1754508}" v="115" dt="2021-12-27T12:24:59.422"/>
    <p1510:client id="{28DB4856-B16B-4CB5-933D-75FCBAF52CD0}" v="2" dt="2021-12-16T15:01:52.249"/>
    <p1510:client id="{393FCA51-F27D-8984-2318-AD4F56619D55}" v="329" dt="2021-12-27T12:43:07.984"/>
    <p1510:client id="{5B9B2400-1B49-E45C-D6AA-61F9F1718DA2}" v="13" dt="2021-12-21T08:25:46.569"/>
    <p1510:client id="{CCE3F3CD-157C-6C44-5960-37417A8E962F}" v="294" dt="2021-12-27T12:57:51.97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42" d="100"/>
          <a:sy n="142" d="100"/>
        </p:scale>
        <p:origin x="714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rina Laura (CREA-OF)" userId="S::marina.laura@crea.gov.it::9427c0f2-f1fa-47e2-b886-e0e87c195ad2" providerId="AD" clId="Web-{086A8C98-401F-A212-3E9B-6C9C81503DAF}"/>
    <pc:docChg chg="modSld">
      <pc:chgData name="Marina Laura (CREA-OF)" userId="S::marina.laura@crea.gov.it::9427c0f2-f1fa-47e2-b886-e0e87c195ad2" providerId="AD" clId="Web-{086A8C98-401F-A212-3E9B-6C9C81503DAF}" dt="2023-04-14T10:53:19.897" v="1" actId="20577"/>
      <pc:docMkLst>
        <pc:docMk/>
      </pc:docMkLst>
      <pc:sldChg chg="modSp">
        <pc:chgData name="Marina Laura (CREA-OF)" userId="S::marina.laura@crea.gov.it::9427c0f2-f1fa-47e2-b886-e0e87c195ad2" providerId="AD" clId="Web-{086A8C98-401F-A212-3E9B-6C9C81503DAF}" dt="2023-04-14T10:53:19.897" v="1" actId="20577"/>
        <pc:sldMkLst>
          <pc:docMk/>
          <pc:sldMk cId="690055434" sldId="256"/>
        </pc:sldMkLst>
        <pc:spChg chg="mod">
          <ac:chgData name="Marina Laura (CREA-OF)" userId="S::marina.laura@crea.gov.it::9427c0f2-f1fa-47e2-b886-e0e87c195ad2" providerId="AD" clId="Web-{086A8C98-401F-A212-3E9B-6C9C81503DAF}" dt="2023-04-14T10:53:19.897" v="1" actId="20577"/>
          <ac:spMkLst>
            <pc:docMk/>
            <pc:sldMk cId="690055434" sldId="256"/>
            <ac:spMk id="2" creationId="{41CE9B8E-D6D3-415C-A083-98C7A195544B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841772"/>
            <a:ext cx="6858000" cy="17907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2701528"/>
            <a:ext cx="6858000" cy="124182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282E0-CECE-A944-BCF4-14FB69938556}" type="datetimeFigureOut">
              <a:rPr lang="en-GB" smtClean="0"/>
              <a:t>14/04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BA383-69B8-E847-A4E4-DFEE540F0DAF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19656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282E0-CECE-A944-BCF4-14FB69938556}" type="datetimeFigureOut">
              <a:rPr lang="en-GB" smtClean="0"/>
              <a:t>14/04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BA383-69B8-E847-A4E4-DFEE540F0DAF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96365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273844"/>
            <a:ext cx="1971675" cy="4358879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273844"/>
            <a:ext cx="5800725" cy="4358879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282E0-CECE-A944-BCF4-14FB69938556}" type="datetimeFigureOut">
              <a:rPr lang="en-GB" smtClean="0"/>
              <a:t>14/04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BA383-69B8-E847-A4E4-DFEE540F0DAF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12961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282E0-CECE-A944-BCF4-14FB69938556}" type="datetimeFigureOut">
              <a:rPr lang="en-GB" smtClean="0"/>
              <a:t>14/04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BA383-69B8-E847-A4E4-DFEE540F0DAF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73414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282304"/>
            <a:ext cx="7886700" cy="2139553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3442098"/>
            <a:ext cx="7886700" cy="1125140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282E0-CECE-A944-BCF4-14FB69938556}" type="datetimeFigureOut">
              <a:rPr lang="en-GB" smtClean="0"/>
              <a:t>14/04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BA383-69B8-E847-A4E4-DFEE540F0DAF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46603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369219"/>
            <a:ext cx="3886200" cy="3263504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369219"/>
            <a:ext cx="3886200" cy="3263504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282E0-CECE-A944-BCF4-14FB69938556}" type="datetimeFigureOut">
              <a:rPr lang="en-GB" smtClean="0"/>
              <a:t>14/04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BA383-69B8-E847-A4E4-DFEE540F0DAF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11159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273844"/>
            <a:ext cx="7886700" cy="99417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260872"/>
            <a:ext cx="3868340" cy="61793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1878806"/>
            <a:ext cx="3868340" cy="2763441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260872"/>
            <a:ext cx="3887391" cy="61793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1878806"/>
            <a:ext cx="3887391" cy="2763441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282E0-CECE-A944-BCF4-14FB69938556}" type="datetimeFigureOut">
              <a:rPr lang="en-GB" smtClean="0"/>
              <a:t>14/04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BA383-69B8-E847-A4E4-DFEE540F0DAF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98654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282E0-CECE-A944-BCF4-14FB69938556}" type="datetimeFigureOut">
              <a:rPr lang="en-GB" smtClean="0"/>
              <a:t>14/04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BA383-69B8-E847-A4E4-DFEE540F0DAF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8581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282E0-CECE-A944-BCF4-14FB69938556}" type="datetimeFigureOut">
              <a:rPr lang="en-GB" smtClean="0"/>
              <a:t>14/04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BA383-69B8-E847-A4E4-DFEE540F0DAF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46575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42900"/>
            <a:ext cx="2949178" cy="120015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740569"/>
            <a:ext cx="4629150" cy="3655219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543050"/>
            <a:ext cx="2949178" cy="285869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282E0-CECE-A944-BCF4-14FB69938556}" type="datetimeFigureOut">
              <a:rPr lang="en-GB" smtClean="0"/>
              <a:t>14/04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BA383-69B8-E847-A4E4-DFEE540F0DAF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06823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42900"/>
            <a:ext cx="2949178" cy="120015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740569"/>
            <a:ext cx="4629150" cy="3655219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543050"/>
            <a:ext cx="2949178" cy="285869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282E0-CECE-A944-BCF4-14FB69938556}" type="datetimeFigureOut">
              <a:rPr lang="en-GB" smtClean="0"/>
              <a:t>14/04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BA383-69B8-E847-A4E4-DFEE540F0DAF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30293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273844"/>
            <a:ext cx="7886700" cy="9941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369219"/>
            <a:ext cx="7886700" cy="326350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4767263"/>
            <a:ext cx="20574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6282E0-CECE-A944-BCF4-14FB69938556}" type="datetimeFigureOut">
              <a:rPr lang="en-GB" smtClean="0"/>
              <a:t>14/04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4767263"/>
            <a:ext cx="30861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4767263"/>
            <a:ext cx="20574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1BA383-69B8-E847-A4E4-DFEE540F0DAF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25014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magine 6" descr="Immagine che contiene pianta, verdura&#10;&#10;Descrizione generata automaticamente">
            <a:extLst>
              <a:ext uri="{FF2B5EF4-FFF2-40B4-BE49-F238E27FC236}">
                <a16:creationId xmlns:a16="http://schemas.microsoft.com/office/drawing/2014/main" id="{B85FF229-43AD-BE42-8642-FA40EFE2C07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3896"/>
          <a:stretch/>
        </p:blipFill>
        <p:spPr>
          <a:xfrm rot="16200000">
            <a:off x="2624706" y="1593676"/>
            <a:ext cx="1438175" cy="1283296"/>
          </a:xfrm>
          <a:prstGeom prst="rect">
            <a:avLst/>
          </a:prstGeom>
        </p:spPr>
      </p:pic>
      <p:pic>
        <p:nvPicPr>
          <p:cNvPr id="9" name="Immagine 8">
            <a:extLst>
              <a:ext uri="{FF2B5EF4-FFF2-40B4-BE49-F238E27FC236}">
                <a16:creationId xmlns:a16="http://schemas.microsoft.com/office/drawing/2014/main" id="{D9D83F65-A9D9-8F43-9529-0940CF56CBC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475" t="7550" r="10035"/>
          <a:stretch/>
        </p:blipFill>
        <p:spPr>
          <a:xfrm rot="16200000">
            <a:off x="3936508" y="1638344"/>
            <a:ext cx="1439783" cy="1192353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id="{41CE9B8E-D6D3-415C-A083-98C7A195544B}"/>
              </a:ext>
            </a:extLst>
          </p:cNvPr>
          <p:cNvSpPr txBox="1"/>
          <p:nvPr/>
        </p:nvSpPr>
        <p:spPr>
          <a:xfrm>
            <a:off x="356347" y="3016038"/>
            <a:ext cx="5521786" cy="40011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GB" sz="1000" b="1"/>
              <a:t>File S5. </a:t>
            </a:r>
            <a:r>
              <a:rPr lang="en-GB" sz="1000"/>
              <a:t>Genetic transformation of </a:t>
            </a:r>
            <a:r>
              <a:rPr lang="en-GB" sz="1000" i="1" err="1"/>
              <a:t>Ocimum</a:t>
            </a:r>
            <a:r>
              <a:rPr lang="en-GB" sz="1000" i="1"/>
              <a:t> </a:t>
            </a:r>
            <a:r>
              <a:rPr lang="en-GB" sz="1000" i="1" err="1"/>
              <a:t>basilicum</a:t>
            </a:r>
            <a:r>
              <a:rPr lang="en-GB" sz="1000" i="1" dirty="0"/>
              <a:t> '</a:t>
            </a:r>
            <a:r>
              <a:rPr lang="en-GB" sz="1000"/>
              <a:t>FT </a:t>
            </a:r>
            <a:r>
              <a:rPr lang="en-GB" sz="1000" err="1"/>
              <a:t>Italiko</a:t>
            </a:r>
            <a:r>
              <a:rPr lang="en-GB" sz="1000" dirty="0"/>
              <a:t>' </a:t>
            </a:r>
            <a:r>
              <a:rPr lang="en-GB" sz="1000" dirty="0">
                <a:ea typeface="+mn-lt"/>
                <a:cs typeface="+mn-lt"/>
              </a:rPr>
              <a:t>with</a:t>
            </a:r>
            <a:r>
              <a:rPr lang="en-GB" sz="1000" i="1">
                <a:ea typeface="+mn-lt"/>
                <a:cs typeface="+mn-lt"/>
              </a:rPr>
              <a:t> A. </a:t>
            </a:r>
            <a:r>
              <a:rPr lang="en-GB" sz="1000" i="1" err="1">
                <a:ea typeface="+mn-lt"/>
                <a:cs typeface="+mn-lt"/>
              </a:rPr>
              <a:t>rhizogenes</a:t>
            </a:r>
            <a:r>
              <a:rPr lang="en-GB" sz="1000" i="1" dirty="0">
                <a:ea typeface="+mn-lt"/>
                <a:cs typeface="+mn-lt"/>
              </a:rPr>
              <a:t> </a:t>
            </a:r>
            <a:r>
              <a:rPr lang="en-GB" sz="1000" dirty="0"/>
              <a:t>(</a:t>
            </a:r>
            <a:r>
              <a:rPr lang="en-GB" sz="1000" b="1" dirty="0"/>
              <a:t>A</a:t>
            </a:r>
            <a:r>
              <a:rPr lang="en-GB" sz="1000" dirty="0"/>
              <a:t>) </a:t>
            </a:r>
            <a:r>
              <a:rPr lang="en-GB" sz="1000" dirty="0">
                <a:ea typeface="+mn-lt"/>
                <a:cs typeface="+mn-lt"/>
              </a:rPr>
              <a:t>Induction of hairy roots (HRs) from callus</a:t>
            </a:r>
            <a:r>
              <a:rPr lang="en-US" sz="1000" dirty="0">
                <a:ea typeface="+mn-lt"/>
                <a:cs typeface="+mn-lt"/>
              </a:rPr>
              <a:t>; </a:t>
            </a:r>
            <a:r>
              <a:rPr lang="en-GB" sz="1000" dirty="0"/>
              <a:t>(</a:t>
            </a:r>
            <a:r>
              <a:rPr lang="en-GB" sz="1000" b="1" dirty="0"/>
              <a:t>B</a:t>
            </a:r>
            <a:r>
              <a:rPr lang="en-GB" sz="1000" dirty="0"/>
              <a:t>) Single and isolated HR representing an independent transgenic line.  </a:t>
            </a:r>
            <a:endParaRPr lang="en-GB" sz="1000" dirty="0">
              <a:cs typeface="Calibri"/>
            </a:endParaRPr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8F50C211-3EB6-467E-8991-F6D50ED26A52}"/>
              </a:ext>
            </a:extLst>
          </p:cNvPr>
          <p:cNvSpPr txBox="1"/>
          <p:nvPr/>
        </p:nvSpPr>
        <p:spPr>
          <a:xfrm>
            <a:off x="3686899" y="2600650"/>
            <a:ext cx="282823" cy="35141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GB" sz="1400">
                <a:solidFill>
                  <a:srgbClr val="FFFFFF"/>
                </a:solidFill>
                <a:cs typeface="Calibri"/>
              </a:rPr>
              <a:t>A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8832ABA2-9D7F-40C9-8A79-E3778133D2C3}"/>
              </a:ext>
            </a:extLst>
          </p:cNvPr>
          <p:cNvSpPr txBox="1"/>
          <p:nvPr/>
        </p:nvSpPr>
        <p:spPr>
          <a:xfrm>
            <a:off x="4970703" y="2633780"/>
            <a:ext cx="282823" cy="30777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GB" sz="1400" dirty="0">
                <a:solidFill>
                  <a:srgbClr val="FFFFFF"/>
                </a:solidFill>
                <a:cs typeface="Calibri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69005543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3</Words>
  <Application>Microsoft Office PowerPoint</Application>
  <PresentationFormat>Presentazione su schermo (16:9)</PresentationFormat>
  <Paragraphs>3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Chiara Forti</dc:creator>
  <cp:lastModifiedBy>Marina Laura (CREA-OF)</cp:lastModifiedBy>
  <cp:revision>59</cp:revision>
  <dcterms:created xsi:type="dcterms:W3CDTF">2021-10-18T09:26:54Z</dcterms:created>
  <dcterms:modified xsi:type="dcterms:W3CDTF">2023-04-14T10:53:26Z</dcterms:modified>
</cp:coreProperties>
</file>